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70" r:id="rId13"/>
    <p:sldId id="271" r:id="rId14"/>
    <p:sldId id="272" r:id="rId15"/>
    <p:sldId id="273" r:id="rId16"/>
    <p:sldId id="274" r:id="rId17"/>
    <p:sldId id="275" r:id="rId18"/>
    <p:sldId id="276" r:id="rId19"/>
    <p:sldId id="277" r:id="rId20"/>
    <p:sldId id="278" r:id="rId21"/>
    <p:sldId id="279" r:id="rId22"/>
    <p:sldId id="280" r:id="rId23"/>
    <p:sldId id="283" r:id="rId24"/>
    <p:sldId id="284" r:id="rId25"/>
    <p:sldId id="285" r:id="rId26"/>
    <p:sldId id="286" r:id="rId27"/>
    <p:sldId id="287" r:id="rId28"/>
    <p:sldId id="288" r:id="rId29"/>
    <p:sldId id="289" r:id="rId30"/>
    <p:sldId id="290" r:id="rId31"/>
    <p:sldId id="312" r:id="rId32"/>
    <p:sldId id="291" r:id="rId33"/>
    <p:sldId id="292" r:id="rId3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694"/>
  </p:normalViewPr>
  <p:slideViewPr>
    <p:cSldViewPr snapToGrid="0" snapToObjects="1">
      <p:cViewPr varScale="1">
        <p:scale>
          <a:sx n="103" d="100"/>
          <a:sy n="103" d="100"/>
        </p:scale>
        <p:origin x="672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895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200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454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559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07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682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154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738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99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4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D39FE-0F59-FE4A-890D-D3C68C5B5898}" type="datetimeFigureOut">
              <a:rPr lang="en-US" smtClean="0"/>
              <a:t>2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AD1A9-D475-C54B-80EA-1A53367BD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121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pH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2" name="TextBox 1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885785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TC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770834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iC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071267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pH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>
          <a:xfrm>
            <a:off x="457200" y="1610832"/>
            <a:ext cx="8229600" cy="4525963"/>
          </a:xfrm>
        </p:spPr>
      </p:pic>
      <p:sp>
        <p:nvSpPr>
          <p:cNvPr id="6" name="TextBox 5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11789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PCO2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591446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D20PO2.37C_ChngCorrectedBF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04881"/>
            <a:ext cx="9144000" cy="54864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328801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HCO3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1550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BE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115150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D20s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5" name="TextBox 4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047266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Glu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890011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N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2797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PCO2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366028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K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>
          <a:xfrm>
            <a:off x="457200" y="1610832"/>
            <a:ext cx="8229600" cy="4525963"/>
          </a:xfrm>
        </p:spPr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915699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TC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289408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0iC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45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460777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pH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39807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PCO2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190310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PO2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222498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HCO3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>
          <a:xfrm>
            <a:off x="457200" y="1605516"/>
            <a:ext cx="8229600" cy="4525963"/>
          </a:xfrm>
        </p:spPr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14486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BE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671395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s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125773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Glu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660456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PO2.37C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476966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N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28061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K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750687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TC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362706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23iC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2258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hronic Heat &amp; ND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251309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HCO3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496521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BE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113197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sO2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3512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Glu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703583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Na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4" name="TextBox 3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601462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14K_ChngCorrectedBF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0" b="4170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345233" y="207220"/>
            <a:ext cx="123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ute He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812180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88</Words>
  <Application>Microsoft Office PowerPoint</Application>
  <PresentationFormat>On-screen Show (4:3)</PresentationFormat>
  <Paragraphs>33</Paragraphs>
  <Slides>33</Slides>
  <Notes>0</Notes>
  <HiddenSlides>22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3</vt:i4>
      </vt:variant>
    </vt:vector>
  </HeadingPairs>
  <TitlesOfParts>
    <vt:vector size="3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ot Saelao</dc:creator>
  <cp:lastModifiedBy>Ying Wang</cp:lastModifiedBy>
  <cp:revision>10</cp:revision>
  <dcterms:created xsi:type="dcterms:W3CDTF">2017-09-27T21:36:59Z</dcterms:created>
  <dcterms:modified xsi:type="dcterms:W3CDTF">2024-02-01T21:49:05Z</dcterms:modified>
</cp:coreProperties>
</file>